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92E2D7-2BCB-4E70-9EF4-10BD851100A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BB1D77-7043-4B55-ADA9-4B5A7921CCA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6EFFB4-2667-4377-82BB-31E9CD7942A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4FDF69-B688-4607-8706-7C59DAD8293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1B8E5C-2C83-4BB2-8415-DEF7986966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F80200-2493-42FE-8DE4-0096883A125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204B8B-B048-4AC4-927C-096541254D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0D7D12-3EE6-47F5-BD09-BA80B9ACC10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15255E-DFD8-4E8C-9B86-3DCEFF3978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560C75-4438-4001-9310-7667390722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49F472-5725-49C1-AD67-44A0A2F8F8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CA7EE2-F2FD-46BC-8D73-5361FC03C6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E8AB0AC-5F44-4672-A6EF-C72A6591A757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230"/>
          <p:cNvSpPr/>
          <p:nvPr/>
        </p:nvSpPr>
        <p:spPr>
          <a:xfrm>
            <a:off x="2455560" y="7924680"/>
            <a:ext cx="2487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 9"/>
          <p:cNvGrpSpPr/>
          <p:nvPr/>
        </p:nvGrpSpPr>
        <p:grpSpPr>
          <a:xfrm>
            <a:off x="1295280" y="1066680"/>
            <a:ext cx="4308480" cy="4356360"/>
            <a:chOff x="1295280" y="1066680"/>
            <a:chExt cx="4308480" cy="4356360"/>
          </a:xfrm>
        </p:grpSpPr>
        <p:grpSp>
          <p:nvGrpSpPr>
            <p:cNvPr id="43" name="Group 17"/>
            <p:cNvGrpSpPr/>
            <p:nvPr/>
          </p:nvGrpSpPr>
          <p:grpSpPr>
            <a:xfrm>
              <a:off x="1295280" y="1066680"/>
              <a:ext cx="4308480" cy="4356360"/>
              <a:chOff x="1295280" y="1066680"/>
              <a:chExt cx="4308480" cy="4356360"/>
            </a:xfrm>
          </p:grpSpPr>
          <p:grpSp>
            <p:nvGrpSpPr>
              <p:cNvPr id="44" name="Group 15"/>
              <p:cNvGrpSpPr/>
              <p:nvPr/>
            </p:nvGrpSpPr>
            <p:grpSpPr>
              <a:xfrm>
                <a:off x="1295280" y="1066680"/>
                <a:ext cx="4308480" cy="4356360"/>
                <a:chOff x="1295280" y="1066680"/>
                <a:chExt cx="4308480" cy="4356360"/>
              </a:xfrm>
            </p:grpSpPr>
            <p:grpSp>
              <p:nvGrpSpPr>
                <p:cNvPr id="45" name="Group 9"/>
                <p:cNvGrpSpPr/>
                <p:nvPr/>
              </p:nvGrpSpPr>
              <p:grpSpPr>
                <a:xfrm>
                  <a:off x="1295280" y="1066680"/>
                  <a:ext cx="4308480" cy="4317840"/>
                  <a:chOff x="1295280" y="1066680"/>
                  <a:chExt cx="4308480" cy="4317840"/>
                </a:xfrm>
              </p:grpSpPr>
              <p:grpSp>
                <p:nvGrpSpPr>
                  <p:cNvPr id="46" name="Oval 3"/>
                  <p:cNvGrpSpPr/>
                  <p:nvPr/>
                </p:nvGrpSpPr>
                <p:grpSpPr>
                  <a:xfrm>
                    <a:off x="1295280" y="1066680"/>
                    <a:ext cx="4308480" cy="4317840"/>
                    <a:chOff x="1295280" y="1066680"/>
                    <a:chExt cx="4308480" cy="4317840"/>
                  </a:xfrm>
                </p:grpSpPr>
                <p:pic>
                  <p:nvPicPr>
                    <p:cNvPr id="47" name="Oval 3" descr=""/>
                    <p:cNvPicPr/>
                    <p:nvPr/>
                  </p:nvPicPr>
                  <p:blipFill>
                    <a:blip r:embed="rId1"/>
                    <a:stretch/>
                  </p:blipFill>
                  <p:spPr>
                    <a:xfrm>
                      <a:off x="1295280" y="1066680"/>
                      <a:ext cx="4308480" cy="43178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48" name=""/>
                    <p:cNvSpPr/>
                    <p:nvPr/>
                  </p:nvSpPr>
                  <p:spPr>
                    <a:xfrm>
                      <a:off x="1966680" y="1718280"/>
                      <a:ext cx="2969640" cy="29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Bd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grpSp>
                <p:nvGrpSpPr>
                  <p:cNvPr id="49" name="Oval 19"/>
                  <p:cNvGrpSpPr/>
                  <p:nvPr/>
                </p:nvGrpSpPr>
                <p:grpSpPr>
                  <a:xfrm>
                    <a:off x="1509120" y="1608480"/>
                    <a:ext cx="3928320" cy="3776040"/>
                    <a:chOff x="1509120" y="1608480"/>
                    <a:chExt cx="3928320" cy="3776040"/>
                  </a:xfrm>
                </p:grpSpPr>
                <p:pic>
                  <p:nvPicPr>
                    <p:cNvPr id="50" name="Oval 19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1509120" y="1608480"/>
                      <a:ext cx="3928320" cy="37760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51" name=""/>
                    <p:cNvSpPr/>
                    <p:nvPr/>
                  </p:nvSpPr>
                  <p:spPr>
                    <a:xfrm>
                      <a:off x="2127600" y="2183040"/>
                      <a:ext cx="2697840" cy="2591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Gra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grpSp>
                <p:nvGrpSpPr>
                  <p:cNvPr id="52" name="Oval 20"/>
                  <p:cNvGrpSpPr/>
                  <p:nvPr/>
                </p:nvGrpSpPr>
                <p:grpSpPr>
                  <a:xfrm>
                    <a:off x="1794240" y="2191680"/>
                    <a:ext cx="3357720" cy="3192840"/>
                    <a:chOff x="1794240" y="2191680"/>
                    <a:chExt cx="3357720" cy="3192840"/>
                  </a:xfrm>
                </p:grpSpPr>
                <p:pic>
                  <p:nvPicPr>
                    <p:cNvPr id="53" name="Oval 20" descr=""/>
                    <p:cNvPicPr/>
                    <p:nvPr/>
                  </p:nvPicPr>
                  <p:blipFill>
                    <a:blip r:embed="rId3"/>
                    <a:stretch/>
                  </p:blipFill>
                  <p:spPr>
                    <a:xfrm>
                      <a:off x="1794240" y="2191680"/>
                      <a:ext cx="3357720" cy="31928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54" name=""/>
                    <p:cNvSpPr/>
                    <p:nvPr/>
                  </p:nvSpPr>
                  <p:spPr>
                    <a:xfrm>
                      <a:off x="2328840" y="2678400"/>
                      <a:ext cx="2295360" cy="21812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grpSp>
                <p:nvGrpSpPr>
                  <p:cNvPr id="55" name="TextBox 6"/>
                  <p:cNvGrpSpPr/>
                  <p:nvPr/>
                </p:nvGrpSpPr>
                <p:grpSpPr>
                  <a:xfrm>
                    <a:off x="2578680" y="1614240"/>
                    <a:ext cx="1705680" cy="683280"/>
                    <a:chOff x="2578680" y="1614240"/>
                    <a:chExt cx="1705680" cy="683280"/>
                  </a:xfrm>
                </p:grpSpPr>
                <p:pic>
                  <p:nvPicPr>
                    <p:cNvPr id="56" name="TextBox 6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2578680" y="1614240"/>
                      <a:ext cx="1705680" cy="6832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57" name=""/>
                    <p:cNvSpPr/>
                    <p:nvPr/>
                  </p:nvSpPr>
                  <p:spPr>
                    <a:xfrm>
                      <a:off x="2639880" y="1662840"/>
                      <a:ext cx="1591920" cy="5806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rassius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1 (79+2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</p:grpSp>
            <p:grpSp>
              <p:nvGrpSpPr>
                <p:cNvPr id="58" name="Oval 17"/>
                <p:cNvGrpSpPr/>
                <p:nvPr/>
              </p:nvGrpSpPr>
              <p:grpSpPr>
                <a:xfrm>
                  <a:off x="1968840" y="2589120"/>
                  <a:ext cx="2993400" cy="2833920"/>
                  <a:chOff x="1968840" y="2589120"/>
                  <a:chExt cx="2993400" cy="2833920"/>
                </a:xfrm>
              </p:grpSpPr>
              <p:pic>
                <p:nvPicPr>
                  <p:cNvPr id="59" name="Oval 17" descr=""/>
                  <p:cNvPicPr/>
                  <p:nvPr/>
                </p:nvPicPr>
                <p:blipFill>
                  <a:blip r:embed="rId5"/>
                  <a:stretch/>
                </p:blipFill>
                <p:spPr>
                  <a:xfrm>
                    <a:off x="1968840" y="2589120"/>
                    <a:ext cx="2993400" cy="2833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60" name=""/>
                  <p:cNvSpPr/>
                  <p:nvPr/>
                </p:nvSpPr>
                <p:spPr>
                  <a:xfrm>
                    <a:off x="2451600" y="3025800"/>
                    <a:ext cx="2035800" cy="1924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800" spc="-1" strike="noStrike">
                        <a:solidFill>
                          <a:srgbClr val="000000"/>
                        </a:solidFill>
                        <a:latin typeface="Calibri"/>
                      </a:rPr>
                      <a:t>PlantTFDB</a:t>
                    </a: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800" spc="-1" strike="noStrike">
                        <a:solidFill>
                          <a:srgbClr val="000000"/>
                        </a:solidFill>
                        <a:latin typeface="Calibri"/>
                      </a:rPr>
                      <a:t>72 (70+2)</a:t>
                    </a: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  <p:sp>
            <p:nvSpPr>
              <p:cNvPr id="61" name="TextBox 15"/>
              <p:cNvSpPr/>
              <p:nvPr/>
            </p:nvSpPr>
            <p:spPr>
              <a:xfrm>
                <a:off x="3012120" y="2165760"/>
                <a:ext cx="86796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NCBI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75 (72+3)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2" name="Group 13"/>
            <p:cNvGrpSpPr/>
            <p:nvPr/>
          </p:nvGrpSpPr>
          <p:grpSpPr>
            <a:xfrm>
              <a:off x="1958040" y="1093320"/>
              <a:ext cx="3091680" cy="528840"/>
              <a:chOff x="1958040" y="1093320"/>
              <a:chExt cx="3091680" cy="528840"/>
            </a:xfrm>
          </p:grpSpPr>
          <p:sp>
            <p:nvSpPr>
              <p:cNvPr id="63" name="TextBox 12"/>
              <p:cNvSpPr/>
              <p:nvPr/>
            </p:nvSpPr>
            <p:spPr>
              <a:xfrm>
                <a:off x="2956680" y="1093320"/>
                <a:ext cx="9828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Calibri"/>
                  </a:rPr>
                  <a:t>86 (83+3)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" name="TextBox 13"/>
              <p:cNvSpPr/>
              <p:nvPr/>
            </p:nvSpPr>
            <p:spPr>
              <a:xfrm>
                <a:off x="1958040" y="1375920"/>
                <a:ext cx="3091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Calibri"/>
                  </a:rPr>
                  <a:t>Database of </a:t>
                </a:r>
                <a:r>
                  <a:rPr b="1" i="1" lang="en-US" sz="1000" spc="-1" strike="noStrike">
                    <a:solidFill>
                      <a:srgbClr val="000000"/>
                    </a:solidFill>
                    <a:latin typeface="Calibri"/>
                  </a:rPr>
                  <a:t>Brachypodium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Calibri"/>
                  </a:rPr>
                  <a:t> WRKY Transcription Factors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0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1-19T17:20:04Z</dcterms:created>
  <dc:creator>paul.rushton</dc:creator>
  <dc:description/>
  <dc:language>en-US</dc:language>
  <cp:lastModifiedBy>paul.rushton</cp:lastModifiedBy>
  <dcterms:modified xsi:type="dcterms:W3CDTF">2012-05-01T19:24:44Z</dcterms:modified>
  <cp:revision>119</cp:revision>
  <dc:subject/>
  <dc:title>Slide 1</dc:title>
</cp:coreProperties>
</file>